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55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orient="horz" pos="73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686" y="102"/>
      </p:cViewPr>
      <p:guideLst>
        <p:guide orient="horz" pos="2455"/>
        <p:guide pos="2880"/>
        <p:guide orient="horz" pos="7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LEMA VALERO CUESTA" userId="7c0a58d0-13c0-4f22-8c26-82db3ac15929" providerId="ADAL" clId="{36F3D525-15DA-460D-8C27-D764C10AC8E3}"/>
    <pc:docChg chg="custSel modSld">
      <pc:chgData name="YULEMA VALERO CUESTA" userId="7c0a58d0-13c0-4f22-8c26-82db3ac15929" providerId="ADAL" clId="{36F3D525-15DA-460D-8C27-D764C10AC8E3}" dt="2024-11-27T12:22:55.426" v="78" actId="20577"/>
      <pc:docMkLst>
        <pc:docMk/>
      </pc:docMkLst>
      <pc:sldChg chg="modSp mod">
        <pc:chgData name="YULEMA VALERO CUESTA" userId="7c0a58d0-13c0-4f22-8c26-82db3ac15929" providerId="ADAL" clId="{36F3D525-15DA-460D-8C27-D764C10AC8E3}" dt="2024-11-27T12:22:55.426" v="78" actId="20577"/>
        <pc:sldMkLst>
          <pc:docMk/>
          <pc:sldMk cId="2774784053" sldId="256"/>
        </pc:sldMkLst>
        <pc:spChg chg="mod">
          <ac:chgData name="YULEMA VALERO CUESTA" userId="7c0a58d0-13c0-4f22-8c26-82db3ac15929" providerId="ADAL" clId="{36F3D525-15DA-460D-8C27-D764C10AC8E3}" dt="2024-11-27T12:19:25.425" v="0" actId="14100"/>
          <ac:spMkLst>
            <pc:docMk/>
            <pc:sldMk cId="2774784053" sldId="256"/>
            <ac:spMk id="8" creationId="{187A393D-0750-A37E-742D-9181C182373E}"/>
          </ac:spMkLst>
        </pc:spChg>
        <pc:spChg chg="mod">
          <ac:chgData name="YULEMA VALERO CUESTA" userId="7c0a58d0-13c0-4f22-8c26-82db3ac15929" providerId="ADAL" clId="{36F3D525-15DA-460D-8C27-D764C10AC8E3}" dt="2024-11-27T12:22:55.426" v="78" actId="20577"/>
          <ac:spMkLst>
            <pc:docMk/>
            <pc:sldMk cId="2774784053" sldId="256"/>
            <ac:spMk id="38" creationId="{D246DA5D-1BDC-9F6A-FD2A-DCED63A699A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0043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991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6892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1862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735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114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151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59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022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6402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866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D0C75E-7984-4F6F-B529-E27E02F8D2B3}" type="datetimeFigureOut">
              <a:rPr lang="en-GB" smtClean="0"/>
              <a:t>11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7C6E1D-9B26-46EF-AE27-D78C5C0E6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02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FE821ADA-44F3-4984-D319-CD1A23A063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7331" y="1508287"/>
            <a:ext cx="3067050" cy="2447925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889F0ED8-59C3-C3CB-3A13-2ED95A62972C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50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1369" y="1423158"/>
            <a:ext cx="2688242" cy="2533054"/>
          </a:xfrm>
          <a:prstGeom prst="rect">
            <a:avLst/>
          </a:prstGeom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8A0F632C-77B6-E590-25DB-CE1DCEC81454}"/>
              </a:ext>
            </a:extLst>
          </p:cNvPr>
          <p:cNvSpPr txBox="1"/>
          <p:nvPr/>
        </p:nvSpPr>
        <p:spPr>
          <a:xfrm rot="16200000">
            <a:off x="2438586" y="2356951"/>
            <a:ext cx="79423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Counts</a:t>
            </a:r>
          </a:p>
        </p:txBody>
      </p:sp>
      <p:pic>
        <p:nvPicPr>
          <p:cNvPr id="25" name="Imagen 24">
            <a:extLst>
              <a:ext uri="{FF2B5EF4-FFF2-40B4-BE49-F238E27FC236}">
                <a16:creationId xmlns:a16="http://schemas.microsoft.com/office/drawing/2014/main" id="{BC9EF901-CFFF-B8B3-4F8C-9359403B7D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65600" y="1534448"/>
            <a:ext cx="3034272" cy="2421764"/>
          </a:xfrm>
          <a:prstGeom prst="rect">
            <a:avLst/>
          </a:prstGeom>
        </p:spPr>
      </p:pic>
      <p:sp>
        <p:nvSpPr>
          <p:cNvPr id="26" name="CuadroTexto 25">
            <a:extLst>
              <a:ext uri="{FF2B5EF4-FFF2-40B4-BE49-F238E27FC236}">
                <a16:creationId xmlns:a16="http://schemas.microsoft.com/office/drawing/2014/main" id="{9517763C-A6B6-5E49-85A0-316223BB0D1B}"/>
              </a:ext>
            </a:extLst>
          </p:cNvPr>
          <p:cNvSpPr txBox="1"/>
          <p:nvPr/>
        </p:nvSpPr>
        <p:spPr>
          <a:xfrm rot="16200000">
            <a:off x="2402492" y="2356951"/>
            <a:ext cx="79423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Counts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46B6E57-36BD-B590-C22B-B1A8B8813934}"/>
              </a:ext>
            </a:extLst>
          </p:cNvPr>
          <p:cNvSpPr txBox="1"/>
          <p:nvPr/>
        </p:nvSpPr>
        <p:spPr>
          <a:xfrm rot="16200000">
            <a:off x="5662279" y="2287610"/>
            <a:ext cx="79423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Counts</a:t>
            </a:r>
          </a:p>
        </p:txBody>
      </p: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D1823DEA-01A1-50E2-4970-7BA8447DA9E6}"/>
              </a:ext>
            </a:extLst>
          </p:cNvPr>
          <p:cNvCxnSpPr>
            <a:cxnSpLocks/>
          </p:cNvCxnSpPr>
          <p:nvPr/>
        </p:nvCxnSpPr>
        <p:spPr>
          <a:xfrm>
            <a:off x="6752260" y="2486015"/>
            <a:ext cx="208065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CuadroTexto 33">
            <a:extLst>
              <a:ext uri="{FF2B5EF4-FFF2-40B4-BE49-F238E27FC236}">
                <a16:creationId xmlns:a16="http://schemas.microsoft.com/office/drawing/2014/main" id="{19ACCA4C-C5A8-2A4C-FFF4-741A03A67E8B}"/>
              </a:ext>
            </a:extLst>
          </p:cNvPr>
          <p:cNvSpPr txBox="1"/>
          <p:nvPr/>
        </p:nvSpPr>
        <p:spPr>
          <a:xfrm>
            <a:off x="7666274" y="2224405"/>
            <a:ext cx="794239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M1</a:t>
            </a:r>
          </a:p>
        </p:txBody>
      </p: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653AF48B-81FD-1497-8E13-14F3DE9BEA0D}"/>
              </a:ext>
            </a:extLst>
          </p:cNvPr>
          <p:cNvCxnSpPr>
            <a:cxnSpLocks/>
          </p:cNvCxnSpPr>
          <p:nvPr/>
        </p:nvCxnSpPr>
        <p:spPr>
          <a:xfrm>
            <a:off x="3835599" y="2750664"/>
            <a:ext cx="193595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D211D9B3-1D86-1A77-8B98-A244F0F25EF4}"/>
              </a:ext>
            </a:extLst>
          </p:cNvPr>
          <p:cNvSpPr txBox="1"/>
          <p:nvPr/>
        </p:nvSpPr>
        <p:spPr>
          <a:xfrm>
            <a:off x="4523911" y="2489054"/>
            <a:ext cx="794239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M1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D246DA5D-1BDC-9F6A-FD2A-DCED63A699A2}"/>
              </a:ext>
            </a:extLst>
          </p:cNvPr>
          <p:cNvSpPr txBox="1"/>
          <p:nvPr/>
        </p:nvSpPr>
        <p:spPr>
          <a:xfrm>
            <a:off x="111369" y="96993"/>
            <a:ext cx="8674412" cy="7694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Palatino Linotype" panose="02040502050505030304" pitchFamily="18" charset="0"/>
              </a:rPr>
              <a:t>Supplementary Figure S1. </a:t>
            </a:r>
            <a:r>
              <a:rPr lang="en-GB" sz="1100" dirty="0">
                <a:latin typeface="Palatino Linotype" panose="02040502050505030304" pitchFamily="18" charset="0"/>
              </a:rPr>
              <a:t>Representative flow cytometry data of the cell lines infected with Ad vectors. A. Representative dot-plot of the population distribution for the cell lines DLB-1, SaB-1 and HEK293T. B,C. Representative fluorescence histograms of mock- and Ad-infected cells corresponding to the cell lines HEK293T (B) and DLB-1 or SaB-1 (C). M1; positive fluorescence.</a:t>
            </a:r>
          </a:p>
          <a:p>
            <a:pPr algn="just"/>
            <a:endParaRPr lang="en-GB" sz="1100" b="1" dirty="0">
              <a:latin typeface="Palatino Linotype" panose="02040502050505030304" pitchFamily="18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C5F73BAC-5C08-A1BE-24D1-6B6E57CC6347}"/>
              </a:ext>
            </a:extLst>
          </p:cNvPr>
          <p:cNvSpPr txBox="1"/>
          <p:nvPr/>
        </p:nvSpPr>
        <p:spPr>
          <a:xfrm>
            <a:off x="14349" y="1141310"/>
            <a:ext cx="7824028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Palatino Linotype" panose="02040502050505030304" pitchFamily="18" charset="0"/>
              </a:rPr>
              <a:t>A)						    B) HEK293T cells					      C) DLB-1 cells</a:t>
            </a:r>
            <a:endParaRPr lang="en-GB" sz="1100" dirty="0">
              <a:latin typeface="Palatino Linotype" panose="02040502050505030304" pitchFamily="18" charset="0"/>
            </a:endParaRPr>
          </a:p>
          <a:p>
            <a:pPr algn="just"/>
            <a:endParaRPr lang="en-GB" sz="1100" b="1" dirty="0">
              <a:latin typeface="Palatino Linotype" panose="02040502050505030304" pitchFamily="18" charset="0"/>
            </a:endParaRPr>
          </a:p>
        </p:txBody>
      </p:sp>
      <p:grpSp>
        <p:nvGrpSpPr>
          <p:cNvPr id="27" name="Grupo 26">
            <a:extLst>
              <a:ext uri="{FF2B5EF4-FFF2-40B4-BE49-F238E27FC236}">
                <a16:creationId xmlns:a16="http://schemas.microsoft.com/office/drawing/2014/main" id="{5A3E152E-86E5-26C3-C7A7-353A5AE12537}"/>
              </a:ext>
            </a:extLst>
          </p:cNvPr>
          <p:cNvGrpSpPr/>
          <p:nvPr/>
        </p:nvGrpSpPr>
        <p:grpSpPr>
          <a:xfrm>
            <a:off x="3357534" y="1423158"/>
            <a:ext cx="2832670" cy="261610"/>
            <a:chOff x="5143504" y="916438"/>
            <a:chExt cx="2832670" cy="261610"/>
          </a:xfrm>
        </p:grpSpPr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A038C377-E8B1-14E4-D93E-B7BAB6CF234C}"/>
                </a:ext>
              </a:extLst>
            </p:cNvPr>
            <p:cNvSpPr txBox="1"/>
            <p:nvPr/>
          </p:nvSpPr>
          <p:spPr>
            <a:xfrm>
              <a:off x="5417531" y="916438"/>
              <a:ext cx="122066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100" dirty="0"/>
                <a:t>Mock-infected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563998F1-A4EA-F37D-A9D1-9A83262A6925}"/>
                </a:ext>
              </a:extLst>
            </p:cNvPr>
            <p:cNvSpPr txBox="1"/>
            <p:nvPr/>
          </p:nvSpPr>
          <p:spPr>
            <a:xfrm>
              <a:off x="6755509" y="916438"/>
              <a:ext cx="122066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100" dirty="0"/>
                <a:t>Ad-infected</a:t>
              </a:r>
            </a:p>
          </p:txBody>
        </p: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CE396BCA-60F8-23F7-2BF4-D0F200E5317B}"/>
                </a:ext>
              </a:extLst>
            </p:cNvPr>
            <p:cNvCxnSpPr/>
            <p:nvPr/>
          </p:nvCxnSpPr>
          <p:spPr>
            <a:xfrm flipH="1">
              <a:off x="6550664" y="1047243"/>
              <a:ext cx="246185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ctor recto 19">
              <a:extLst>
                <a:ext uri="{FF2B5EF4-FFF2-40B4-BE49-F238E27FC236}">
                  <a16:creationId xmlns:a16="http://schemas.microsoft.com/office/drawing/2014/main" id="{DAD91A4C-1647-37F6-A289-E5038C9B9930}"/>
                </a:ext>
              </a:extLst>
            </p:cNvPr>
            <p:cNvCxnSpPr/>
            <p:nvPr/>
          </p:nvCxnSpPr>
          <p:spPr>
            <a:xfrm flipH="1">
              <a:off x="5143504" y="1049729"/>
              <a:ext cx="246185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upo 5">
            <a:extLst>
              <a:ext uri="{FF2B5EF4-FFF2-40B4-BE49-F238E27FC236}">
                <a16:creationId xmlns:a16="http://schemas.microsoft.com/office/drawing/2014/main" id="{F1D5D3F0-15CE-B224-8989-C5968E8265FC}"/>
              </a:ext>
            </a:extLst>
          </p:cNvPr>
          <p:cNvGrpSpPr/>
          <p:nvPr/>
        </p:nvGrpSpPr>
        <p:grpSpPr>
          <a:xfrm>
            <a:off x="6431217" y="1423158"/>
            <a:ext cx="2627826" cy="261610"/>
            <a:chOff x="5143504" y="916438"/>
            <a:chExt cx="2627826" cy="261610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B7D5880-193A-92EA-0393-2734059ACD37}"/>
                </a:ext>
              </a:extLst>
            </p:cNvPr>
            <p:cNvSpPr txBox="1"/>
            <p:nvPr/>
          </p:nvSpPr>
          <p:spPr>
            <a:xfrm>
              <a:off x="5417531" y="916438"/>
              <a:ext cx="122066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100" dirty="0"/>
                <a:t>Mock-infected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87A393D-0750-A37E-742D-9181C182373E}"/>
                </a:ext>
              </a:extLst>
            </p:cNvPr>
            <p:cNvSpPr txBox="1"/>
            <p:nvPr/>
          </p:nvSpPr>
          <p:spPr>
            <a:xfrm>
              <a:off x="6755510" y="916438"/>
              <a:ext cx="1015820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100" dirty="0"/>
                <a:t>Ad-infected</a:t>
              </a:r>
            </a:p>
          </p:txBody>
        </p:sp>
        <p:cxnSp>
          <p:nvCxnSpPr>
            <p:cNvPr id="9" name="Conector recto 8">
              <a:extLst>
                <a:ext uri="{FF2B5EF4-FFF2-40B4-BE49-F238E27FC236}">
                  <a16:creationId xmlns:a16="http://schemas.microsoft.com/office/drawing/2014/main" id="{24C8963E-3721-58CC-9CFD-98830D520D08}"/>
                </a:ext>
              </a:extLst>
            </p:cNvPr>
            <p:cNvCxnSpPr/>
            <p:nvPr/>
          </p:nvCxnSpPr>
          <p:spPr>
            <a:xfrm flipH="1">
              <a:off x="6550664" y="1047243"/>
              <a:ext cx="246185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C2080437-63F2-45DB-5457-0511E20221E2}"/>
                </a:ext>
              </a:extLst>
            </p:cNvPr>
            <p:cNvCxnSpPr/>
            <p:nvPr/>
          </p:nvCxnSpPr>
          <p:spPr>
            <a:xfrm flipH="1">
              <a:off x="5143504" y="1049729"/>
              <a:ext cx="246185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747840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</TotalTime>
  <Words>100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LEMA VALERO CUESTA</dc:creator>
  <cp:lastModifiedBy>MDPI</cp:lastModifiedBy>
  <cp:revision>5</cp:revision>
  <dcterms:created xsi:type="dcterms:W3CDTF">2024-11-26T22:15:20Z</dcterms:created>
  <dcterms:modified xsi:type="dcterms:W3CDTF">2024-12-11T05:32:46Z</dcterms:modified>
</cp:coreProperties>
</file>